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  <p:sldId id="279" r:id="rId25"/>
    <p:sldId id="280" r:id="rId26"/>
    <p:sldId id="281" r:id="rId2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187" autoAdjust="0"/>
    <p:restoredTop sz="94660"/>
  </p:normalViewPr>
  <p:slideViewPr>
    <p:cSldViewPr snapToGrid="0">
      <p:cViewPr varScale="1">
        <p:scale>
          <a:sx n="88" d="100"/>
          <a:sy n="88" d="100"/>
        </p:scale>
        <p:origin x="102" y="6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 smtClean="0"/>
              <a:t>Kattintson ide az alcím mintájának szerkesztéséhez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9C269-43A7-4B05-91A4-F5E08710509A}" type="datetimeFigureOut">
              <a:rPr lang="hu-HU" smtClean="0"/>
              <a:t>2022. 02. 03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3FF23-9430-4405-B5D5-EA172D29E20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6226827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9C269-43A7-4B05-91A4-F5E08710509A}" type="datetimeFigureOut">
              <a:rPr lang="hu-HU" smtClean="0"/>
              <a:t>2022. 02. 03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3FF23-9430-4405-B5D5-EA172D29E20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0226697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9C269-43A7-4B05-91A4-F5E08710509A}" type="datetimeFigureOut">
              <a:rPr lang="hu-HU" smtClean="0"/>
              <a:t>2022. 02. 03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3FF23-9430-4405-B5D5-EA172D29E20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9427941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9C269-43A7-4B05-91A4-F5E08710509A}" type="datetimeFigureOut">
              <a:rPr lang="hu-HU" smtClean="0"/>
              <a:t>2022. 02. 03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3FF23-9430-4405-B5D5-EA172D29E20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23385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9C269-43A7-4B05-91A4-F5E08710509A}" type="datetimeFigureOut">
              <a:rPr lang="hu-HU" smtClean="0"/>
              <a:t>2022. 02. 03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3FF23-9430-4405-B5D5-EA172D29E20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6424881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9C269-43A7-4B05-91A4-F5E08710509A}" type="datetimeFigureOut">
              <a:rPr lang="hu-HU" smtClean="0"/>
              <a:t>2022. 02. 03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3FF23-9430-4405-B5D5-EA172D29E20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3932613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9C269-43A7-4B05-91A4-F5E08710509A}" type="datetimeFigureOut">
              <a:rPr lang="hu-HU" smtClean="0"/>
              <a:t>2022. 02. 03.</a:t>
            </a:fld>
            <a:endParaRPr lang="hu-H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3FF23-9430-4405-B5D5-EA172D29E20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8881936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9C269-43A7-4B05-91A4-F5E08710509A}" type="datetimeFigureOut">
              <a:rPr lang="hu-HU" smtClean="0"/>
              <a:t>2022. 02. 03.</a:t>
            </a:fld>
            <a:endParaRPr lang="hu-H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3FF23-9430-4405-B5D5-EA172D29E20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8938501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9C269-43A7-4B05-91A4-F5E08710509A}" type="datetimeFigureOut">
              <a:rPr lang="hu-HU" smtClean="0"/>
              <a:t>2022. 02. 03.</a:t>
            </a:fld>
            <a:endParaRPr lang="hu-H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3FF23-9430-4405-B5D5-EA172D29E20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9211492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9C269-43A7-4B05-91A4-F5E08710509A}" type="datetimeFigureOut">
              <a:rPr lang="hu-HU" smtClean="0"/>
              <a:t>2022. 02. 03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3FF23-9430-4405-B5D5-EA172D29E20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7322905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hu-HU" smtClean="0"/>
              <a:t>Kép beszúrásához kattintson az ikonr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9C269-43A7-4B05-91A4-F5E08710509A}" type="datetimeFigureOut">
              <a:rPr lang="hu-HU" smtClean="0"/>
              <a:t>2022. 02. 03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3FF23-9430-4405-B5D5-EA172D29E20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4984906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59C269-43A7-4B05-91A4-F5E08710509A}" type="datetimeFigureOut">
              <a:rPr lang="hu-HU" smtClean="0"/>
              <a:t>2022. 02. 03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63FF23-9430-4405-B5D5-EA172D29E20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8111121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e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jpe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jpe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jpe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jpe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jpe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jpeg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Kép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5496"/>
            <a:ext cx="9144000" cy="6467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780992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Kép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5496"/>
            <a:ext cx="9144000" cy="6467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333767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Kép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5496"/>
            <a:ext cx="9144000" cy="6467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8487805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Kép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5496"/>
            <a:ext cx="9144000" cy="6467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5714155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Kép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5496"/>
            <a:ext cx="9144000" cy="6467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7763911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Kép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5496"/>
            <a:ext cx="9144000" cy="6467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6621608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Kép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5496"/>
            <a:ext cx="9144000" cy="6467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580999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Kép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5496"/>
            <a:ext cx="9144000" cy="6467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325345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Kép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5496"/>
            <a:ext cx="9144000" cy="6467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559219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Kép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5496"/>
            <a:ext cx="9144000" cy="6467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36356262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Kép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5496"/>
            <a:ext cx="9144000" cy="6467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98406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Kép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5496"/>
            <a:ext cx="9144000" cy="6467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13529030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Kép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5496"/>
            <a:ext cx="9144000" cy="6467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50851818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Kép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5496"/>
            <a:ext cx="9144000" cy="6467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8442914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Kép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5496"/>
            <a:ext cx="9144000" cy="6467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83983776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Kép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5496"/>
            <a:ext cx="9144000" cy="6467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3718728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Kép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5496"/>
            <a:ext cx="9144000" cy="6467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72306106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Kép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5496"/>
            <a:ext cx="9144000" cy="6467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4687024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Kép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5496"/>
            <a:ext cx="9144000" cy="6467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021908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Kép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5496"/>
            <a:ext cx="9144000" cy="6467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43317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Kép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5496"/>
            <a:ext cx="9144000" cy="6467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329272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Kép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5496"/>
            <a:ext cx="9144000" cy="6467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3091807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Kép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5496"/>
            <a:ext cx="9144000" cy="6467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9997566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Kép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5496"/>
            <a:ext cx="9144000" cy="6467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855716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Kép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5496"/>
            <a:ext cx="9144000" cy="6467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6172841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Kép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5496"/>
            <a:ext cx="9144000" cy="6467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29259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-té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é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</TotalTime>
  <Words>0</Words>
  <Application>Microsoft Office PowerPoint</Application>
  <PresentationFormat>Diavetítés a képernyőre (4:3 oldalarány)</PresentationFormat>
  <Paragraphs>0</Paragraphs>
  <Slides>26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3</vt:i4>
      </vt:variant>
      <vt:variant>
        <vt:lpstr>Téma</vt:lpstr>
      </vt:variant>
      <vt:variant>
        <vt:i4>1</vt:i4>
      </vt:variant>
      <vt:variant>
        <vt:lpstr>Diacímek</vt:lpstr>
      </vt:variant>
      <vt:variant>
        <vt:i4>26</vt:i4>
      </vt:variant>
    </vt:vector>
  </HeadingPairs>
  <TitlesOfParts>
    <vt:vector size="30" baseType="lpstr">
      <vt:lpstr>Arial</vt:lpstr>
      <vt:lpstr>Calibri</vt:lpstr>
      <vt:lpstr>Calibri Light</vt:lpstr>
      <vt:lpstr>Office-téma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Windows-felhasználó</dc:creator>
  <cp:lastModifiedBy>Windows-felhasználó</cp:lastModifiedBy>
  <cp:revision>2</cp:revision>
  <dcterms:created xsi:type="dcterms:W3CDTF">2022-02-03T13:21:19Z</dcterms:created>
  <dcterms:modified xsi:type="dcterms:W3CDTF">2022-02-03T13:39:20Z</dcterms:modified>
</cp:coreProperties>
</file>